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2CB4431-B48C-4335-82FE-68B46F1AFCF2}" v="1" dt="2025-03-11T11:02:12.1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3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kira Ouchi" userId="3da18b59e1d60f73" providerId="LiveId" clId="{A3F497D4-63CF-4D66-9099-B37D8EDE2789}"/>
    <pc:docChg chg="delSld modSld">
      <pc:chgData name="Akira Ouchi" userId="3da18b59e1d60f73" providerId="LiveId" clId="{A3F497D4-63CF-4D66-9099-B37D8EDE2789}" dt="2024-12-12T14:55:13.288" v="53" actId="2696"/>
      <pc:docMkLst>
        <pc:docMk/>
      </pc:docMkLst>
      <pc:sldChg chg="modSp mod">
        <pc:chgData name="Akira Ouchi" userId="3da18b59e1d60f73" providerId="LiveId" clId="{A3F497D4-63CF-4D66-9099-B37D8EDE2789}" dt="2024-08-27T13:33:12.929" v="44" actId="6549"/>
        <pc:sldMkLst>
          <pc:docMk/>
          <pc:sldMk cId="430399478" sldId="316"/>
        </pc:sldMkLst>
      </pc:sldChg>
      <pc:sldChg chg="modSp mod">
        <pc:chgData name="Akira Ouchi" userId="3da18b59e1d60f73" providerId="LiveId" clId="{A3F497D4-63CF-4D66-9099-B37D8EDE2789}" dt="2024-08-27T13:33:05.173" v="36" actId="6549"/>
        <pc:sldMkLst>
          <pc:docMk/>
          <pc:sldMk cId="2673606678" sldId="317"/>
        </pc:sldMkLst>
      </pc:sldChg>
      <pc:sldChg chg="modSp mod">
        <pc:chgData name="Akira Ouchi" userId="3da18b59e1d60f73" providerId="LiveId" clId="{A3F497D4-63CF-4D66-9099-B37D8EDE2789}" dt="2024-08-27T13:33:09.348" v="40" actId="6549"/>
        <pc:sldMkLst>
          <pc:docMk/>
          <pc:sldMk cId="3170936020" sldId="319"/>
        </pc:sldMkLst>
      </pc:sldChg>
      <pc:sldChg chg="modSp mod">
        <pc:chgData name="Akira Ouchi" userId="3da18b59e1d60f73" providerId="LiveId" clId="{A3F497D4-63CF-4D66-9099-B37D8EDE2789}" dt="2024-08-27T13:33:00.259" v="32" actId="20577"/>
        <pc:sldMkLst>
          <pc:docMk/>
          <pc:sldMk cId="36269307" sldId="320"/>
        </pc:sldMkLst>
      </pc:sldChg>
      <pc:sldChg chg="modSp mod">
        <pc:chgData name="Akira Ouchi" userId="3da18b59e1d60f73" providerId="LiveId" clId="{A3F497D4-63CF-4D66-9099-B37D8EDE2789}" dt="2024-08-27T13:33:20.211" v="52" actId="6549"/>
        <pc:sldMkLst>
          <pc:docMk/>
          <pc:sldMk cId="484831294" sldId="323"/>
        </pc:sldMkLst>
      </pc:sldChg>
      <pc:sldChg chg="modSp mod">
        <pc:chgData name="Akira Ouchi" userId="3da18b59e1d60f73" providerId="LiveId" clId="{A3F497D4-63CF-4D66-9099-B37D8EDE2789}" dt="2024-08-24T04:32:35.232" v="0" actId="1582"/>
        <pc:sldMkLst>
          <pc:docMk/>
          <pc:sldMk cId="3526519749" sldId="334"/>
        </pc:sldMkLst>
      </pc:sldChg>
      <pc:sldChg chg="modSp mod">
        <pc:chgData name="Akira Ouchi" userId="3da18b59e1d60f73" providerId="LiveId" clId="{A3F497D4-63CF-4D66-9099-B37D8EDE2789}" dt="2024-08-27T13:33:16.807" v="48" actId="6549"/>
        <pc:sldMkLst>
          <pc:docMk/>
          <pc:sldMk cId="2209211313" sldId="336"/>
        </pc:sldMkLst>
      </pc:sldChg>
      <pc:sldChg chg="del">
        <pc:chgData name="Akira Ouchi" userId="3da18b59e1d60f73" providerId="LiveId" clId="{A3F497D4-63CF-4D66-9099-B37D8EDE2789}" dt="2024-12-12T14:55:13.288" v="53" actId="2696"/>
        <pc:sldMkLst>
          <pc:docMk/>
          <pc:sldMk cId="2657868269" sldId="337"/>
        </pc:sldMkLst>
      </pc:sldChg>
    </pc:docChg>
  </pc:docChgLst>
  <pc:docChgLst>
    <pc:chgData name="Akira Ouchi" userId="3da18b59e1d60f73" providerId="LiveId" clId="{A9CB7344-896B-42F9-8A17-3AFCE3169580}"/>
    <pc:docChg chg="delSld">
      <pc:chgData name="Akira Ouchi" userId="3da18b59e1d60f73" providerId="LiveId" clId="{A9CB7344-896B-42F9-8A17-3AFCE3169580}" dt="2024-12-24T11:25:17.724" v="0" actId="2696"/>
      <pc:docMkLst>
        <pc:docMk/>
      </pc:docMkLst>
      <pc:sldChg chg="del">
        <pc:chgData name="Akira Ouchi" userId="3da18b59e1d60f73" providerId="LiveId" clId="{A9CB7344-896B-42F9-8A17-3AFCE3169580}" dt="2024-12-24T11:25:17.724" v="0" actId="2696"/>
        <pc:sldMkLst>
          <pc:docMk/>
          <pc:sldMk cId="430399478" sldId="316"/>
        </pc:sldMkLst>
      </pc:sldChg>
      <pc:sldChg chg="del">
        <pc:chgData name="Akira Ouchi" userId="3da18b59e1d60f73" providerId="LiveId" clId="{A9CB7344-896B-42F9-8A17-3AFCE3169580}" dt="2024-12-24T11:25:17.724" v="0" actId="2696"/>
        <pc:sldMkLst>
          <pc:docMk/>
          <pc:sldMk cId="2673606678" sldId="317"/>
        </pc:sldMkLst>
      </pc:sldChg>
      <pc:sldChg chg="del">
        <pc:chgData name="Akira Ouchi" userId="3da18b59e1d60f73" providerId="LiveId" clId="{A9CB7344-896B-42F9-8A17-3AFCE3169580}" dt="2024-12-24T11:25:17.724" v="0" actId="2696"/>
        <pc:sldMkLst>
          <pc:docMk/>
          <pc:sldMk cId="3170936020" sldId="319"/>
        </pc:sldMkLst>
      </pc:sldChg>
    </pc:docChg>
  </pc:docChgLst>
  <pc:docChgLst>
    <pc:chgData name="Akira Ouchi" userId="3da18b59e1d60f73" providerId="LiveId" clId="{7665C00C-04DE-44F7-ADEF-2FA3354DBB51}"/>
    <pc:docChg chg="undo custSel addSld delSld modSld sldOrd">
      <pc:chgData name="Akira Ouchi" userId="3da18b59e1d60f73" providerId="LiveId" clId="{7665C00C-04DE-44F7-ADEF-2FA3354DBB51}" dt="2024-08-26T06:23:38.024" v="726" actId="20577"/>
      <pc:docMkLst>
        <pc:docMk/>
      </pc:docMkLst>
      <pc:sldChg chg="addSp delSp modSp mod">
        <pc:chgData name="Akira Ouchi" userId="3da18b59e1d60f73" providerId="LiveId" clId="{7665C00C-04DE-44F7-ADEF-2FA3354DBB51}" dt="2024-08-24T02:36:40.036" v="257" actId="404"/>
        <pc:sldMkLst>
          <pc:docMk/>
          <pc:sldMk cId="978796953" sldId="256"/>
        </pc:sldMkLst>
      </pc:sldChg>
      <pc:sldChg chg="new del">
        <pc:chgData name="Akira Ouchi" userId="3da18b59e1d60f73" providerId="LiveId" clId="{7665C00C-04DE-44F7-ADEF-2FA3354DBB51}" dt="2024-08-24T02:24:40.428" v="108" actId="2696"/>
        <pc:sldMkLst>
          <pc:docMk/>
          <pc:sldMk cId="1096343627" sldId="257"/>
        </pc:sldMkLst>
      </pc:sldChg>
      <pc:sldChg chg="addSp delSp modSp add mod">
        <pc:chgData name="Akira Ouchi" userId="3da18b59e1d60f73" providerId="LiveId" clId="{7665C00C-04DE-44F7-ADEF-2FA3354DBB51}" dt="2024-08-24T02:45:46.382" v="458" actId="20577"/>
        <pc:sldMkLst>
          <pc:docMk/>
          <pc:sldMk cId="430399478" sldId="316"/>
        </pc:sldMkLst>
      </pc:sldChg>
      <pc:sldChg chg="addSp delSp modSp add mod">
        <pc:chgData name="Akira Ouchi" userId="3da18b59e1d60f73" providerId="LiveId" clId="{7665C00C-04DE-44F7-ADEF-2FA3354DBB51}" dt="2024-08-24T02:54:25.306" v="706" actId="20577"/>
        <pc:sldMkLst>
          <pc:docMk/>
          <pc:sldMk cId="2673606678" sldId="317"/>
        </pc:sldMkLst>
      </pc:sldChg>
      <pc:sldChg chg="addSp delSp modSp add mod ord">
        <pc:chgData name="Akira Ouchi" userId="3da18b59e1d60f73" providerId="LiveId" clId="{7665C00C-04DE-44F7-ADEF-2FA3354DBB51}" dt="2024-08-24T02:50:59.062" v="661"/>
        <pc:sldMkLst>
          <pc:docMk/>
          <pc:sldMk cId="3170936020" sldId="319"/>
        </pc:sldMkLst>
      </pc:sldChg>
      <pc:sldChg chg="addSp delSp modSp add mod">
        <pc:chgData name="Akira Ouchi" userId="3da18b59e1d60f73" providerId="LiveId" clId="{7665C00C-04DE-44F7-ADEF-2FA3354DBB51}" dt="2024-08-24T02:54:12.307" v="693" actId="20577"/>
        <pc:sldMkLst>
          <pc:docMk/>
          <pc:sldMk cId="36269307" sldId="320"/>
        </pc:sldMkLst>
      </pc:sldChg>
      <pc:sldChg chg="addSp delSp modSp add mod">
        <pc:chgData name="Akira Ouchi" userId="3da18b59e1d60f73" providerId="LiveId" clId="{7665C00C-04DE-44F7-ADEF-2FA3354DBB51}" dt="2024-08-24T02:52:48.433" v="688" actId="1076"/>
        <pc:sldMkLst>
          <pc:docMk/>
          <pc:sldMk cId="484831294" sldId="323"/>
        </pc:sldMkLst>
      </pc:sldChg>
      <pc:sldChg chg="addSp delSp modSp add mod">
        <pc:chgData name="Akira Ouchi" userId="3da18b59e1d60f73" providerId="LiveId" clId="{7665C00C-04DE-44F7-ADEF-2FA3354DBB51}" dt="2024-08-26T06:23:38.024" v="726" actId="20577"/>
        <pc:sldMkLst>
          <pc:docMk/>
          <pc:sldMk cId="3526519749" sldId="334"/>
        </pc:sldMkLst>
      </pc:sldChg>
      <pc:sldChg chg="delSp new del mod">
        <pc:chgData name="Akira Ouchi" userId="3da18b59e1d60f73" providerId="LiveId" clId="{7665C00C-04DE-44F7-ADEF-2FA3354DBB51}" dt="2024-08-24T02:31:16.717" v="120" actId="2696"/>
        <pc:sldMkLst>
          <pc:docMk/>
          <pc:sldMk cId="2945271688" sldId="335"/>
        </pc:sldMkLst>
      </pc:sldChg>
      <pc:sldChg chg="addSp delSp modSp new mod">
        <pc:chgData name="Akira Ouchi" userId="3da18b59e1d60f73" providerId="LiveId" clId="{7665C00C-04DE-44F7-ADEF-2FA3354DBB51}" dt="2024-08-24T02:50:30.617" v="649" actId="20577"/>
        <pc:sldMkLst>
          <pc:docMk/>
          <pc:sldMk cId="2209211313" sldId="336"/>
        </pc:sldMkLst>
      </pc:sldChg>
      <pc:sldChg chg="new">
        <pc:chgData name="Akira Ouchi" userId="3da18b59e1d60f73" providerId="LiveId" clId="{7665C00C-04DE-44F7-ADEF-2FA3354DBB51}" dt="2024-08-24T02:29:22.601" v="115" actId="680"/>
        <pc:sldMkLst>
          <pc:docMk/>
          <pc:sldMk cId="2657868269" sldId="337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1302361765" sldId="338"/>
        </pc:sldMkLst>
      </pc:sldChg>
      <pc:sldChg chg="new del">
        <pc:chgData name="Akira Ouchi" userId="3da18b59e1d60f73" providerId="LiveId" clId="{7665C00C-04DE-44F7-ADEF-2FA3354DBB51}" dt="2024-08-24T02:29:49.276" v="119" actId="47"/>
        <pc:sldMkLst>
          <pc:docMk/>
          <pc:sldMk cId="2657678063" sldId="338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3209479371" sldId="339"/>
        </pc:sldMkLst>
      </pc:sldChg>
    </pc:docChg>
  </pc:docChgLst>
  <pc:docChgLst>
    <pc:chgData name="Akira Ouchi" userId="3da18b59e1d60f73" providerId="LiveId" clId="{27AAABF1-9238-4101-B67E-D5B1596E4369}"/>
    <pc:docChg chg="undo custSel modSld">
      <pc:chgData name="Akira Ouchi" userId="3da18b59e1d60f73" providerId="LiveId" clId="{27AAABF1-9238-4101-B67E-D5B1596E4369}" dt="2024-11-06T05:58:48.571" v="49"/>
      <pc:docMkLst>
        <pc:docMk/>
      </pc:docMkLst>
      <pc:sldChg chg="addSp delSp modSp mod">
        <pc:chgData name="Akira Ouchi" userId="3da18b59e1d60f73" providerId="LiveId" clId="{27AAABF1-9238-4101-B67E-D5B1596E4369}" dt="2024-11-06T05:53:53.497" v="16" actId="478"/>
        <pc:sldMkLst>
          <pc:docMk/>
          <pc:sldMk cId="430399478" sldId="316"/>
        </pc:sldMkLst>
      </pc:sldChg>
      <pc:sldChg chg="addSp delSp modSp mod">
        <pc:chgData name="Akira Ouchi" userId="3da18b59e1d60f73" providerId="LiveId" clId="{27AAABF1-9238-4101-B67E-D5B1596E4369}" dt="2024-11-06T05:57:59.089" v="37"/>
        <pc:sldMkLst>
          <pc:docMk/>
          <pc:sldMk cId="2673606678" sldId="317"/>
        </pc:sldMkLst>
      </pc:sldChg>
      <pc:sldChg chg="addSp delSp modSp mod">
        <pc:chgData name="Akira Ouchi" userId="3da18b59e1d60f73" providerId="LiveId" clId="{27AAABF1-9238-4101-B67E-D5B1596E4369}" dt="2024-11-06T05:54:15.267" v="21"/>
        <pc:sldMkLst>
          <pc:docMk/>
          <pc:sldMk cId="3170936020" sldId="319"/>
        </pc:sldMkLst>
      </pc:sldChg>
      <pc:sldChg chg="addSp delSp modSp mod">
        <pc:chgData name="Akira Ouchi" userId="3da18b59e1d60f73" providerId="LiveId" clId="{27AAABF1-9238-4101-B67E-D5B1596E4369}" dt="2024-11-06T05:55:31.693" v="26"/>
        <pc:sldMkLst>
          <pc:docMk/>
          <pc:sldMk cId="36269307" sldId="320"/>
        </pc:sldMkLst>
      </pc:sldChg>
      <pc:sldChg chg="addSp delSp modSp mod">
        <pc:chgData name="Akira Ouchi" userId="3da18b59e1d60f73" providerId="LiveId" clId="{27AAABF1-9238-4101-B67E-D5B1596E4369}" dt="2024-11-06T05:52:09.154" v="6"/>
        <pc:sldMkLst>
          <pc:docMk/>
          <pc:sldMk cId="484831294" sldId="323"/>
        </pc:sldMkLst>
      </pc:sldChg>
      <pc:sldChg chg="addSp delSp modSp mod">
        <pc:chgData name="Akira Ouchi" userId="3da18b59e1d60f73" providerId="LiveId" clId="{27AAABF1-9238-4101-B67E-D5B1596E4369}" dt="2024-11-06T05:58:48.571" v="49"/>
        <pc:sldMkLst>
          <pc:docMk/>
          <pc:sldMk cId="2209211313" sldId="336"/>
        </pc:sldMkLst>
      </pc:sldChg>
    </pc:docChg>
  </pc:docChgLst>
  <pc:docChgLst>
    <pc:chgData name="Akira Ouchi" userId="3da18b59e1d60f73" providerId="LiveId" clId="{92CB4431-B48C-4335-82FE-68B46F1AFCF2}"/>
    <pc:docChg chg="custSel modSld">
      <pc:chgData name="Akira Ouchi" userId="3da18b59e1d60f73" providerId="LiveId" clId="{92CB4431-B48C-4335-82FE-68B46F1AFCF2}" dt="2025-03-11T12:02:10.166" v="7" actId="2711"/>
      <pc:docMkLst>
        <pc:docMk/>
      </pc:docMkLst>
      <pc:sldChg chg="addSp delSp modSp mod">
        <pc:chgData name="Akira Ouchi" userId="3da18b59e1d60f73" providerId="LiveId" clId="{92CB4431-B48C-4335-82FE-68B46F1AFCF2}" dt="2025-03-11T12:02:10.166" v="7" actId="2711"/>
        <pc:sldMkLst>
          <pc:docMk/>
          <pc:sldMk cId="36269307" sldId="320"/>
        </pc:sldMkLst>
        <pc:spChg chg="add mod">
          <ac:chgData name="Akira Ouchi" userId="3da18b59e1d60f73" providerId="LiveId" clId="{92CB4431-B48C-4335-82FE-68B46F1AFCF2}" dt="2025-03-11T11:02:15.451" v="6" actId="1036"/>
          <ac:spMkLst>
            <pc:docMk/>
            <pc:sldMk cId="36269307" sldId="320"/>
            <ac:spMk id="2" creationId="{8B125B86-E2D2-7341-2846-AB027562C337}"/>
          </ac:spMkLst>
        </pc:spChg>
        <pc:spChg chg="add mod">
          <ac:chgData name="Akira Ouchi" userId="3da18b59e1d60f73" providerId="LiveId" clId="{92CB4431-B48C-4335-82FE-68B46F1AFCF2}" dt="2025-03-11T11:02:15.451" v="6" actId="1036"/>
          <ac:spMkLst>
            <pc:docMk/>
            <pc:sldMk cId="36269307" sldId="320"/>
            <ac:spMk id="3" creationId="{9C4CC6B7-29D4-5D73-47C2-4522E1AF7A76}"/>
          </ac:spMkLst>
        </pc:spChg>
        <pc:spChg chg="add mod">
          <ac:chgData name="Akira Ouchi" userId="3da18b59e1d60f73" providerId="LiveId" clId="{92CB4431-B48C-4335-82FE-68B46F1AFCF2}" dt="2025-03-11T11:02:15.451" v="6" actId="1036"/>
          <ac:spMkLst>
            <pc:docMk/>
            <pc:sldMk cId="36269307" sldId="320"/>
            <ac:spMk id="4" creationId="{F3BE708E-A035-B435-FAE9-569EA6B41D58}"/>
          </ac:spMkLst>
        </pc:spChg>
        <pc:spChg chg="mod">
          <ac:chgData name="Akira Ouchi" userId="3da18b59e1d60f73" providerId="LiveId" clId="{92CB4431-B48C-4335-82FE-68B46F1AFCF2}" dt="2025-03-11T12:02:10.166" v="7" actId="2711"/>
          <ac:spMkLst>
            <pc:docMk/>
            <pc:sldMk cId="36269307" sldId="320"/>
            <ac:spMk id="5" creationId="{64662105-79C8-7D48-F8DB-73819916F09F}"/>
          </ac:spMkLst>
        </pc:spChg>
        <pc:spChg chg="del mod">
          <ac:chgData name="Akira Ouchi" userId="3da18b59e1d60f73" providerId="LiveId" clId="{92CB4431-B48C-4335-82FE-68B46F1AFCF2}" dt="2025-03-11T11:01:55.488" v="3" actId="478"/>
          <ac:spMkLst>
            <pc:docMk/>
            <pc:sldMk cId="36269307" sldId="320"/>
            <ac:spMk id="15" creationId="{38160AB1-ABB5-56DD-87A2-92F89BBC07D2}"/>
          </ac:spMkLst>
        </pc:spChg>
        <pc:spChg chg="del mod">
          <ac:chgData name="Akira Ouchi" userId="3da18b59e1d60f73" providerId="LiveId" clId="{92CB4431-B48C-4335-82FE-68B46F1AFCF2}" dt="2025-03-11T11:01:55.488" v="3" actId="478"/>
          <ac:spMkLst>
            <pc:docMk/>
            <pc:sldMk cId="36269307" sldId="320"/>
            <ac:spMk id="16" creationId="{D9D1F858-1316-AC46-1D1D-2F0BD650561A}"/>
          </ac:spMkLst>
        </pc:spChg>
        <pc:spChg chg="del mod">
          <ac:chgData name="Akira Ouchi" userId="3da18b59e1d60f73" providerId="LiveId" clId="{92CB4431-B48C-4335-82FE-68B46F1AFCF2}" dt="2025-03-11T11:01:55.488" v="3" actId="478"/>
          <ac:spMkLst>
            <pc:docMk/>
            <pc:sldMk cId="36269307" sldId="320"/>
            <ac:spMk id="17" creationId="{C9B2CDA8-3E31-F485-82D2-50EFB2F89505}"/>
          </ac:spMkLst>
        </pc:spChg>
        <pc:picChg chg="add mod">
          <ac:chgData name="Akira Ouchi" userId="3da18b59e1d60f73" providerId="LiveId" clId="{92CB4431-B48C-4335-82FE-68B46F1AFCF2}" dt="2025-03-11T11:02:15.451" v="6" actId="1036"/>
          <ac:picMkLst>
            <pc:docMk/>
            <pc:sldMk cId="36269307" sldId="320"/>
            <ac:picMk id="6" creationId="{C1AAE536-09A7-C7F0-A1F6-ADC85B8805C4}"/>
          </ac:picMkLst>
        </pc:picChg>
        <pc:picChg chg="add mod">
          <ac:chgData name="Akira Ouchi" userId="3da18b59e1d60f73" providerId="LiveId" clId="{92CB4431-B48C-4335-82FE-68B46F1AFCF2}" dt="2025-03-11T11:02:15.451" v="6" actId="1036"/>
          <ac:picMkLst>
            <pc:docMk/>
            <pc:sldMk cId="36269307" sldId="320"/>
            <ac:picMk id="7" creationId="{0389DF9F-8824-EF17-CF36-25B5F34E8C78}"/>
          </ac:picMkLst>
        </pc:picChg>
        <pc:picChg chg="add mod">
          <ac:chgData name="Akira Ouchi" userId="3da18b59e1d60f73" providerId="LiveId" clId="{92CB4431-B48C-4335-82FE-68B46F1AFCF2}" dt="2025-03-11T11:02:15.451" v="6" actId="1036"/>
          <ac:picMkLst>
            <pc:docMk/>
            <pc:sldMk cId="36269307" sldId="320"/>
            <ac:picMk id="8" creationId="{D642D916-91FA-4EF4-F4B8-DC99399060C0}"/>
          </ac:picMkLst>
        </pc:picChg>
        <pc:picChg chg="del">
          <ac:chgData name="Akira Ouchi" userId="3da18b59e1d60f73" providerId="LiveId" clId="{92CB4431-B48C-4335-82FE-68B46F1AFCF2}" dt="2025-03-11T11:01:55.488" v="3" actId="478"/>
          <ac:picMkLst>
            <pc:docMk/>
            <pc:sldMk cId="36269307" sldId="320"/>
            <ac:picMk id="18" creationId="{A16FE942-A01C-564E-BC54-83F9254852DB}"/>
          </ac:picMkLst>
        </pc:picChg>
        <pc:picChg chg="del">
          <ac:chgData name="Akira Ouchi" userId="3da18b59e1d60f73" providerId="LiveId" clId="{92CB4431-B48C-4335-82FE-68B46F1AFCF2}" dt="2025-03-11T11:01:55.488" v="3" actId="478"/>
          <ac:picMkLst>
            <pc:docMk/>
            <pc:sldMk cId="36269307" sldId="320"/>
            <ac:picMk id="19" creationId="{AD07E210-1C15-C715-8307-C0B447CD1C0D}"/>
          </ac:picMkLst>
        </pc:picChg>
        <pc:picChg chg="del">
          <ac:chgData name="Akira Ouchi" userId="3da18b59e1d60f73" providerId="LiveId" clId="{92CB4431-B48C-4335-82FE-68B46F1AFCF2}" dt="2025-03-11T11:01:55.488" v="3" actId="478"/>
          <ac:picMkLst>
            <pc:docMk/>
            <pc:sldMk cId="36269307" sldId="320"/>
            <ac:picMk id="20" creationId="{B6357CFC-BADD-9BF5-2CC4-5EAAF1D9C696}"/>
          </ac:picMkLst>
        </pc:picChg>
      </pc:sldChg>
    </pc:docChg>
  </pc:docChgLst>
  <pc:docChgLst>
    <pc:chgData name="Akira Ouchi" userId="3da18b59e1d60f73" providerId="LiveId" clId="{C99AD3AB-F44A-4646-8D6E-4C0A93682AEC}"/>
    <pc:docChg chg="modSld">
      <pc:chgData name="Akira Ouchi" userId="3da18b59e1d60f73" providerId="LiveId" clId="{C99AD3AB-F44A-4646-8D6E-4C0A93682AEC}" dt="2024-07-12T05:58:51.263" v="0" actId="20577"/>
      <pc:docMkLst>
        <pc:docMk/>
      </pc:docMkLst>
      <pc:sldChg chg="modSp mod">
        <pc:chgData name="Akira Ouchi" userId="3da18b59e1d60f73" providerId="LiveId" clId="{C99AD3AB-F44A-4646-8D6E-4C0A93682AEC}" dt="2024-07-12T05:58:51.263" v="0" actId="20577"/>
        <pc:sldMkLst>
          <pc:docMk/>
          <pc:sldMk cId="978796953" sldId="25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811128-71D7-4B27-929C-44BEBF665BD5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7D4F56-7F9F-4B04-A4C0-B0589A75D3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235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7D4F56-7F9F-4B04-A4C0-B0589A75D38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147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BDE2BD-1CE0-6045-E301-CCB7170C49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9A2D957-4FA2-EC91-A1D4-64F9EABD7A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B9044B-E7C9-19CC-4D30-43BF5E433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6CAE3F-B2AE-6115-B53A-A043098B1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3A2845-D4B6-2B78-5D62-C09B921CA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282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DBD759-21BA-C364-1D1A-4EC9A115F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526E5C-160A-1F1C-EE2B-C61786051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D1E6B7-0319-6925-10D4-A91140AA1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0C8ABF-AD90-D3DE-C1DD-DF8663B6E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7AF6D9-E8A6-2D67-721A-8F1DEF006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593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C9F6456-4EA6-CF30-F624-FF0A1FEB8F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EACF61-0933-F9D0-E6F5-932D18C69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3CF8FE-3980-9488-E274-900450640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96F038-600F-8374-2E18-11A0668C2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61BD97-375D-6777-C4F6-0B7C32E91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995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5A20A6-A424-ED56-E9EA-4BF432E1F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957EEE-E15B-9F61-7BF1-57A5D5795A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C9BE29-FD3F-6219-E01D-8C261B308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48BDE6-E8F8-325A-1CF6-010967E13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5B2D25-2598-62F6-68F9-5C1351AA9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60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697EC4-05B9-E85E-28FB-08741F801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F0B3EA-6B33-512C-CEB0-8922116197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630495-F2A3-87A2-7E09-26F946D8A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1DA0E0-BB9C-CF48-9CC1-748B7A2E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38F3A1-D485-5CB6-96CB-3B85695E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050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9C08A7-60D2-8691-841B-813B1CC0C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4515A7-CF93-49A1-3CC7-4B4F79A7B6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8FFFF6-FBC9-44A6-5022-2D4DC48344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6B8E1D-8DB5-0D44-5063-EDDDA0DA1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A54B9B-ED14-B1BC-799C-42407891F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69C050-3239-35DB-2DB9-358EF308C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33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73156-CC01-16A9-B4F9-E5DA4731D7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D22BE4-6C91-F310-EF07-4F4332693D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45E6F8-7DB2-1F62-7F49-810323CDA0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6C8A4A-9915-9556-45E0-2AF1648FD5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9D9FCF9-AAA0-70A2-53CF-95EC67F21A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8296F6-9BE7-446F-707B-93E4A777E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AB0578-7B6B-7DA9-B003-01AB82898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C3A955A-86EF-4D72-A546-464B3FC4B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658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17CF12-5892-7F38-1369-272748354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9C3720C-93F5-BAC7-B486-DA76CF37F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2110B6-39F5-DFBD-E114-5AA222BB5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C16756E-77D0-A53A-CA72-FF917C677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69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FE2EBD9-74F5-50B0-3867-4AB51B9E0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175489-1B30-D6D1-2FD6-6B37A2F67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B556469-32DE-36D1-7CB2-77757200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851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BD3CB-499B-4748-72B1-5A6E71B20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21888A-A65B-F645-E59C-9F18775DB5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BD0AA-BC28-775D-C64A-FCBEDBE74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B41E21-D8E2-FD0F-CDB0-7A93293BA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7E7FBD-61A6-73BB-DAA2-94EB185EA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019B2E-E404-A0C5-501B-A88BEA7C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727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E0F45C-FCE9-FB2B-F2DE-A0E1EF358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EEA8F11-DFB4-531E-F19E-F7C8D5C985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20309F-E54E-9F3F-8B01-FC7DD35F3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9AE2BD-270B-A1AF-2505-370301CD6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312380-B8DB-8AC4-5020-5307DD316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372365-4DEF-A63E-D2FA-EB495A61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202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5B3F53C-2662-436C-F253-31A401947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03F3BA-383F-FC3F-101D-350935744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578D5-ECB4-0CDB-FE88-4AD74BE228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C32F6F-A946-B5CB-D110-D8EC247BCC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DF4C1-0B32-A0AE-3E89-70688011A6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856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21">
            <a:extLst>
              <a:ext uri="{FF2B5EF4-FFF2-40B4-BE49-F238E27FC236}">
                <a16:creationId xmlns:a16="http://schemas.microsoft.com/office/drawing/2014/main" id="{64662105-79C8-7D48-F8DB-73819916F09F}"/>
              </a:ext>
            </a:extLst>
          </p:cNvPr>
          <p:cNvSpPr txBox="1"/>
          <p:nvPr/>
        </p:nvSpPr>
        <p:spPr>
          <a:xfrm>
            <a:off x="0" y="6083051"/>
            <a:ext cx="12191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Bef>
                <a:spcPts val="600"/>
              </a:spcBef>
            </a:pP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4.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ve-year overall survival in patients with positive lymph node metastasis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eft-sided colon cancers by tumor location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B125B86-E2D2-7341-2846-AB027562C337}"/>
              </a:ext>
            </a:extLst>
          </p:cNvPr>
          <p:cNvSpPr txBox="1"/>
          <p:nvPr/>
        </p:nvSpPr>
        <p:spPr>
          <a:xfrm>
            <a:off x="4471837" y="981997"/>
            <a:ext cx="1933863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gmoid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C4CC6B7-29D4-5D73-47C2-4522E1AF7A76}"/>
              </a:ext>
            </a:extLst>
          </p:cNvPr>
          <p:cNvSpPr txBox="1"/>
          <p:nvPr/>
        </p:nvSpPr>
        <p:spPr>
          <a:xfrm>
            <a:off x="7942420" y="986832"/>
            <a:ext cx="2515882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ctosigmoid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3BE708E-A035-B435-FAE9-569EA6B41D58}"/>
              </a:ext>
            </a:extLst>
          </p:cNvPr>
          <p:cNvSpPr txBox="1"/>
          <p:nvPr/>
        </p:nvSpPr>
        <p:spPr>
          <a:xfrm>
            <a:off x="401756" y="986010"/>
            <a:ext cx="2310569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scending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1AAE536-09A7-C7F0-A1F6-ADC85B8805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3771" y="1608898"/>
            <a:ext cx="3796309" cy="412521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389DF9F-8824-EF17-CF36-25B5F34E8C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23853" y="1607472"/>
            <a:ext cx="3796309" cy="412521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642D916-91FA-4EF4-F4B8-DC99399060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371" y="1600053"/>
            <a:ext cx="3927080" cy="4236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9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31</Words>
  <Application>Microsoft Office PowerPoint</Application>
  <PresentationFormat>ワイド画面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kira Ouchi</dc:creator>
  <cp:lastModifiedBy>Akira Ouchi</cp:lastModifiedBy>
  <cp:revision>4</cp:revision>
  <dcterms:created xsi:type="dcterms:W3CDTF">2024-07-12T05:48:55Z</dcterms:created>
  <dcterms:modified xsi:type="dcterms:W3CDTF">2025-03-11T12:02:11Z</dcterms:modified>
</cp:coreProperties>
</file>